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6" d="100"/>
          <a:sy n="126" d="100"/>
        </p:scale>
        <p:origin x="-19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142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93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055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367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037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80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0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088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077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906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446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6DD14-FD50-244E-8D52-DE4F61F2EB84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B718BD-AEE4-DC40-8D0C-8983ADC6E1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27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up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591" y="0"/>
            <a:ext cx="6883185" cy="68580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" y="0"/>
            <a:ext cx="4139997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Gene ontology annotations identified major subgroups as up-regulated in </a:t>
            </a:r>
            <a:r>
              <a:rPr lang="en-US" i="1" dirty="0" smtClean="0"/>
              <a:t>cyp79b2/cyp79b3 </a:t>
            </a:r>
            <a:r>
              <a:rPr lang="en-US" dirty="0" smtClean="0"/>
              <a:t>as </a:t>
            </a:r>
            <a:r>
              <a:rPr lang="en-US" dirty="0"/>
              <a:t>visualized by </a:t>
            </a:r>
            <a:r>
              <a:rPr lang="en-US" dirty="0" err="1"/>
              <a:t>BiNG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8869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own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0"/>
            <a:ext cx="7911885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029326" y="13972"/>
            <a:ext cx="41146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Gene ontology annotations identified major subgroups as </a:t>
            </a:r>
            <a:r>
              <a:rPr lang="en-US" dirty="0" smtClean="0"/>
              <a:t>down-</a:t>
            </a:r>
            <a:r>
              <a:rPr lang="en-US" dirty="0"/>
              <a:t>regulated in </a:t>
            </a:r>
            <a:r>
              <a:rPr lang="en-US" i="1" dirty="0" smtClean="0"/>
              <a:t>cyp79b2/cyp79b3 </a:t>
            </a:r>
            <a:r>
              <a:rPr lang="en-US" dirty="0" smtClean="0"/>
              <a:t>as visualized by </a:t>
            </a:r>
            <a:r>
              <a:rPr lang="en-US" dirty="0" err="1" smtClean="0"/>
              <a:t>BiNG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7388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7721CD8D-B65A-4462-A864-E8F4D19F35C1}"/>
</file>

<file path=customXml/itemProps2.xml><?xml version="1.0" encoding="utf-8"?>
<ds:datastoreItem xmlns:ds="http://schemas.openxmlformats.org/officeDocument/2006/customXml" ds:itemID="{CBFCFCD1-D5C6-41F8-8670-633B1268088A}"/>
</file>

<file path=customXml/itemProps3.xml><?xml version="1.0" encoding="utf-8"?>
<ds:datastoreItem xmlns:ds="http://schemas.openxmlformats.org/officeDocument/2006/customXml" ds:itemID="{09A484B8-C428-49BB-BB5D-D7C62A819141}"/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6</Words>
  <Application>Microsoft Macintosh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entro de Biotecnología y Genómica de Plant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 Pollmann</dc:creator>
  <cp:lastModifiedBy>Stephan Pollmann</cp:lastModifiedBy>
  <cp:revision>1</cp:revision>
  <dcterms:created xsi:type="dcterms:W3CDTF">2016-11-29T17:24:51Z</dcterms:created>
  <dcterms:modified xsi:type="dcterms:W3CDTF">2016-11-29T17:34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